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9" r:id="rId2"/>
    <p:sldId id="260" r:id="rId3"/>
    <p:sldId id="261" r:id="rId4"/>
    <p:sldId id="262" r:id="rId5"/>
    <p:sldId id="263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925"/>
    <p:restoredTop sz="94674"/>
  </p:normalViewPr>
  <p:slideViewPr>
    <p:cSldViewPr snapToGrid="0">
      <p:cViewPr varScale="1">
        <p:scale>
          <a:sx n="124" d="100"/>
          <a:sy n="124" d="100"/>
        </p:scale>
        <p:origin x="125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ABEEE6-59ED-F247-B4A2-3F007E2E1BD4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B1ADC2-7409-3E45-9B17-6126E627DA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8902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B1ADC2-7409-3E45-9B17-6126E627DA5A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9756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B1ADC2-7409-3E45-9B17-6126E627DA5A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24837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B1ADC2-7409-3E45-9B17-6126E627DA5A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157669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B1ADC2-7409-3E45-9B17-6126E627DA5A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18300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B1ADC2-7409-3E45-9B17-6126E627DA5A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72128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051DC90-D9D0-739B-7CB6-004E9726F6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5422FDFB-D161-5CA4-9E1B-949943C728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FBDA76B-A2A1-1D23-752A-77D3E8D0C4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5B6C159-5846-0D4D-BD88-44C4233091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FD03C1B-0730-3249-0B95-0319E74BF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5210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B168FD6-4785-9918-A544-361D32F313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44E5A2F-4618-0ADA-7009-5F332C40C8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E4A75AD-BCFF-DF23-A702-E6E81DF38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993995C-58CB-A0F0-3666-D3DA7F77C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B7BA84F-75A5-CFBB-3E9F-AC95FC119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8074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06ECBF49-AC1A-64C1-A3FA-F537ECA6C0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104B3F1-8C74-B8E3-959A-287D03BD85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2A87360-4F00-6437-8AB8-E9F6FBC9E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A296A41-75F3-D200-72D3-13FEBFE0F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87BEAA4-23F7-922B-3CC4-0BA1DA417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1254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36EAF1A-8296-D659-3CB5-AC1A5CB0E7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2D0941B-1F97-C2BA-FA74-B960E0F517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CB2FAC6-D5B9-B32C-FC71-7FCCBFB111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AC41D6C-6B10-C250-8617-B9B1446A55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626BF59-374E-8B2D-2A57-E7AC239EFD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1833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DAC914A-4F17-E5B6-2886-B4FE8BA13D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01B551A-C5E7-3EC0-ED95-80BC38E6FA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FA4408D-E922-2A69-421F-8E71F9D84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D816B5A-66CC-AF36-3786-D440259E7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F986DD3-E18C-DB86-2169-8BB113636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1614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74953C9-D24B-8134-5ADA-3B9F9A9CD2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63C83D4-2DCE-C992-8D11-DD3CB3F12B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A7E9429-4A1B-5586-70B1-8150C1F658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8B5643B-A77F-5E93-E87C-B6B17C8D4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2F64583-651F-8E3A-6D8B-4C37BC301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001B5EE-D305-750A-B97A-4C8645620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17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2F32041-E649-3245-BA9F-D53A430882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5E8CE88-508F-E9B7-081A-C8CCE145D9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D53956B-845F-18C4-4B1F-09FAB9FDAD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C47F3591-1B8F-D4A5-6268-F3C52FABCB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6C022D8-8BE2-4810-9827-E881C577AF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16414D5-6EC5-731D-9FCC-BDB9117E67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76BA6FD9-0198-20A3-C368-FCFBC1E4A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CDC06E86-C907-91CA-7404-D1A07BE2D7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0611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41E33B-A10E-7632-EC8E-FC0D65B097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B010532-6BD6-4271-AA76-10B26883C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80BECB1A-5A1E-7DBE-5ECB-9C2F89946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6EA12D72-0C90-1CC0-BE06-7DC5A2C02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6698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2EBEDDAF-E5B3-6367-6E93-9022E562C7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DD9E8F6D-AB46-2C70-C4E4-7CB9ADF78A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314CBFF3-7346-FDD1-06C5-88127312D5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0115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1C9249B-6D2E-D23D-EB61-2BA12B9E31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99E8965-2EB7-FCE7-C63E-8A7A28DBB5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ED16ECF-355B-34FC-74FD-0CC65ED837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2E7FC8D-D9E3-FA7C-C642-E5C03F742C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A5578C3-EB61-ECAA-AF30-C13851EC4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EB26FA6-7421-CAEB-96F4-6D564447A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1557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47A47B-02D5-C9D3-FCAF-51EC2B7705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9E56BC99-52FB-E4ED-935F-AC07C848A5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9F1EE69-9374-6C47-A4B6-89C0413294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F4C33F8-6D67-36CE-FEAF-9932CA483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1819F42-EF78-7D21-09E8-BE208AD2C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B2AA995-25D6-E94A-92E5-E1CFA75AF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24584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A28F146-3047-752C-1BEC-26B62F068D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A4C0894-301A-C839-C5B1-5CAE382FED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ED28BB6-3261-C335-95D5-A15D7407A5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4BC7E-5C13-9F4C-A3B1-7A5788E5147B}" type="datetimeFigureOut">
              <a:rPr lang="de-DE" smtClean="0"/>
              <a:t>04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7F2FFC8-7BD0-F09D-183A-D933AA38A8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C6B10C7-722E-810E-B0A3-50DA6E3528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DC61C6-5494-E14F-A54B-716BD16AD2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0468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gif"/><Relationship Id="rId4" Type="http://schemas.openxmlformats.org/officeDocument/2006/relationships/image" Target="../media/image2.g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g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gif"/><Relationship Id="rId4" Type="http://schemas.openxmlformats.org/officeDocument/2006/relationships/image" Target="../media/image5.g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g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gif"/><Relationship Id="rId4" Type="http://schemas.openxmlformats.org/officeDocument/2006/relationships/image" Target="../media/image8.g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g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gif"/><Relationship Id="rId4" Type="http://schemas.openxmlformats.org/officeDocument/2006/relationships/image" Target="../media/image11.g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g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gif"/><Relationship Id="rId4" Type="http://schemas.openxmlformats.org/officeDocument/2006/relationships/image" Target="../media/image14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6D3AC61-4055-3939-C659-B8C7709820A3}"/>
              </a:ext>
            </a:extLst>
          </p:cNvPr>
          <p:cNvSpPr txBox="1"/>
          <p:nvPr/>
        </p:nvSpPr>
        <p:spPr>
          <a:xfrm>
            <a:off x="387502" y="302718"/>
            <a:ext cx="2273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g(II)PpIX, 20 </a:t>
            </a:r>
            <a:r>
              <a:rPr lang="de-DE" dirty="0" err="1"/>
              <a:t>ns</a:t>
            </a:r>
            <a:r>
              <a:rPr lang="de-DE" dirty="0"/>
              <a:t> </a:t>
            </a:r>
            <a:r>
              <a:rPr lang="de-DE" dirty="0" err="1"/>
              <a:t>each</a:t>
            </a:r>
            <a:endParaRPr lang="de-DE" baseline="30000" dirty="0"/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E6EE3EE5-AC8E-E4CC-B68C-B7BDCC51B5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40000"/>
            <a:ext cx="5422900" cy="3048000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5629A6E1-01F2-5D7E-3B35-F9A52810F80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69102" y="1440000"/>
            <a:ext cx="5422900" cy="3048000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698BB2F7-C3EB-E3A0-7CA6-729E1863188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6851" r="21680"/>
          <a:stretch/>
        </p:blipFill>
        <p:spPr>
          <a:xfrm>
            <a:off x="4513810" y="1440000"/>
            <a:ext cx="3333405" cy="3048000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767470A0-B134-2738-848B-66FEA94C7349}"/>
              </a:ext>
            </a:extLst>
          </p:cNvPr>
          <p:cNvSpPr txBox="1"/>
          <p:nvPr/>
        </p:nvSpPr>
        <p:spPr>
          <a:xfrm>
            <a:off x="2252325" y="466967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04436</a:t>
            </a:r>
            <a:endParaRPr lang="de-DE" baseline="30000" dirty="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2FC4EE42-8419-4ADC-983F-B32F33B44B0D}"/>
              </a:ext>
            </a:extLst>
          </p:cNvPr>
          <p:cNvSpPr txBox="1"/>
          <p:nvPr/>
        </p:nvSpPr>
        <p:spPr>
          <a:xfrm>
            <a:off x="5744370" y="466967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07888</a:t>
            </a:r>
            <a:endParaRPr lang="de-DE" baseline="30000" dirty="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446AA7F1-3C46-75EB-74E0-B43466770200}"/>
              </a:ext>
            </a:extLst>
          </p:cNvPr>
          <p:cNvSpPr txBox="1"/>
          <p:nvPr/>
        </p:nvSpPr>
        <p:spPr>
          <a:xfrm>
            <a:off x="9319541" y="466967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50314</a:t>
            </a:r>
            <a:endParaRPr lang="de-DE" baseline="30000" dirty="0"/>
          </a:p>
        </p:txBody>
      </p:sp>
    </p:spTree>
    <p:extLst>
      <p:ext uri="{BB962C8B-B14F-4D97-AF65-F5344CB8AC3E}">
        <p14:creationId xmlns:p14="http://schemas.microsoft.com/office/powerpoint/2010/main" val="2305605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6D3AC61-4055-3939-C659-B8C7709820A3}"/>
              </a:ext>
            </a:extLst>
          </p:cNvPr>
          <p:cNvSpPr txBox="1"/>
          <p:nvPr/>
        </p:nvSpPr>
        <p:spPr>
          <a:xfrm>
            <a:off x="387502" y="302718"/>
            <a:ext cx="2281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Ga(III)PpIX, 20 </a:t>
            </a:r>
            <a:r>
              <a:rPr lang="de-DE" dirty="0" err="1"/>
              <a:t>ns</a:t>
            </a:r>
            <a:r>
              <a:rPr lang="de-DE" dirty="0"/>
              <a:t> </a:t>
            </a:r>
            <a:r>
              <a:rPr lang="de-DE" dirty="0" err="1"/>
              <a:t>each</a:t>
            </a:r>
            <a:endParaRPr lang="de-DE" baseline="30000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767470A0-B134-2738-848B-66FEA94C7349}"/>
              </a:ext>
            </a:extLst>
          </p:cNvPr>
          <p:cNvSpPr txBox="1"/>
          <p:nvPr/>
        </p:nvSpPr>
        <p:spPr>
          <a:xfrm>
            <a:off x="2252325" y="4669671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9320</a:t>
            </a:r>
          </a:p>
          <a:p>
            <a:endParaRPr lang="de-DE" baseline="30000" dirty="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2FC4EE42-8419-4ADC-983F-B32F33B44B0D}"/>
              </a:ext>
            </a:extLst>
          </p:cNvPr>
          <p:cNvSpPr txBox="1"/>
          <p:nvPr/>
        </p:nvSpPr>
        <p:spPr>
          <a:xfrm>
            <a:off x="5744370" y="466967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37550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446AA7F1-3C46-75EB-74E0-B43466770200}"/>
              </a:ext>
            </a:extLst>
          </p:cNvPr>
          <p:cNvSpPr txBox="1"/>
          <p:nvPr/>
        </p:nvSpPr>
        <p:spPr>
          <a:xfrm>
            <a:off x="9319541" y="466967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56699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C9C69B99-FCB7-2AA0-27AE-E8ECC2AFD3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40000"/>
            <a:ext cx="5422900" cy="304800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B956C587-B1C5-C37E-0E96-892833554D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69102" y="1440000"/>
            <a:ext cx="5422900" cy="3048000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E14F5C98-038D-0629-F02D-16852E91A5D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6379" r="19240"/>
          <a:stretch/>
        </p:blipFill>
        <p:spPr>
          <a:xfrm>
            <a:off x="4272742" y="1440000"/>
            <a:ext cx="3491345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29591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6D3AC61-4055-3939-C659-B8C7709820A3}"/>
              </a:ext>
            </a:extLst>
          </p:cNvPr>
          <p:cNvSpPr txBox="1"/>
          <p:nvPr/>
        </p:nvSpPr>
        <p:spPr>
          <a:xfrm>
            <a:off x="387502" y="302718"/>
            <a:ext cx="2226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Ni(II)PpIX, 20 </a:t>
            </a:r>
            <a:r>
              <a:rPr lang="de-DE" dirty="0" err="1"/>
              <a:t>ns</a:t>
            </a:r>
            <a:r>
              <a:rPr lang="de-DE" dirty="0"/>
              <a:t> </a:t>
            </a:r>
            <a:r>
              <a:rPr lang="de-DE" dirty="0" err="1"/>
              <a:t>each</a:t>
            </a:r>
            <a:endParaRPr lang="de-DE" baseline="30000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767470A0-B134-2738-848B-66FEA94C7349}"/>
              </a:ext>
            </a:extLst>
          </p:cNvPr>
          <p:cNvSpPr txBox="1"/>
          <p:nvPr/>
        </p:nvSpPr>
        <p:spPr>
          <a:xfrm>
            <a:off x="2252325" y="466967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4448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2FC4EE42-8419-4ADC-983F-B32F33B44B0D}"/>
              </a:ext>
            </a:extLst>
          </p:cNvPr>
          <p:cNvSpPr txBox="1"/>
          <p:nvPr/>
        </p:nvSpPr>
        <p:spPr>
          <a:xfrm>
            <a:off x="5744370" y="466967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5635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446AA7F1-3C46-75EB-74E0-B43466770200}"/>
              </a:ext>
            </a:extLst>
          </p:cNvPr>
          <p:cNvSpPr txBox="1"/>
          <p:nvPr/>
        </p:nvSpPr>
        <p:spPr>
          <a:xfrm>
            <a:off x="9319541" y="466967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7053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C651754E-8089-EB46-0692-6A4F1698BF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40000"/>
            <a:ext cx="4787900" cy="304800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E16D3D3B-67B5-7298-C432-4B4FCDC0C6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10459" y="1440000"/>
            <a:ext cx="4165600" cy="3048000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2F171594-1E60-C217-03B9-BDBF9E6AAA2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35900" y="1440000"/>
            <a:ext cx="43561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65132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6D3AC61-4055-3939-C659-B8C7709820A3}"/>
              </a:ext>
            </a:extLst>
          </p:cNvPr>
          <p:cNvSpPr txBox="1"/>
          <p:nvPr/>
        </p:nvSpPr>
        <p:spPr>
          <a:xfrm>
            <a:off x="387502" y="302718"/>
            <a:ext cx="30299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g(II)PpIX, N803G, 20 </a:t>
            </a:r>
            <a:r>
              <a:rPr lang="de-DE" dirty="0" err="1"/>
              <a:t>ns</a:t>
            </a:r>
            <a:r>
              <a:rPr lang="de-DE" dirty="0"/>
              <a:t> </a:t>
            </a:r>
            <a:r>
              <a:rPr lang="de-DE" dirty="0" err="1"/>
              <a:t>each</a:t>
            </a:r>
            <a:endParaRPr lang="de-DE" baseline="30000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767470A0-B134-2738-848B-66FEA94C7349}"/>
              </a:ext>
            </a:extLst>
          </p:cNvPr>
          <p:cNvSpPr txBox="1"/>
          <p:nvPr/>
        </p:nvSpPr>
        <p:spPr>
          <a:xfrm>
            <a:off x="2252325" y="466967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4088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2FC4EE42-8419-4ADC-983F-B32F33B44B0D}"/>
              </a:ext>
            </a:extLst>
          </p:cNvPr>
          <p:cNvSpPr txBox="1"/>
          <p:nvPr/>
        </p:nvSpPr>
        <p:spPr>
          <a:xfrm>
            <a:off x="5744370" y="466967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29615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446AA7F1-3C46-75EB-74E0-B43466770200}"/>
              </a:ext>
            </a:extLst>
          </p:cNvPr>
          <p:cNvSpPr txBox="1"/>
          <p:nvPr/>
        </p:nvSpPr>
        <p:spPr>
          <a:xfrm>
            <a:off x="9319541" y="466967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64197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749C4CCE-BD98-374A-C2D9-2CEE6A872A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" y="1440000"/>
            <a:ext cx="5422900" cy="304800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3BD9E418-82E7-B849-7FE2-8A503FE2F31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69101" y="1440000"/>
            <a:ext cx="5422900" cy="3048000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B73DC0E3-545A-4430-AE7D-140139C7206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7911" r="21539"/>
          <a:stretch/>
        </p:blipFill>
        <p:spPr>
          <a:xfrm>
            <a:off x="4355868" y="1440000"/>
            <a:ext cx="3283527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17214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6D3AC61-4055-3939-C659-B8C7709820A3}"/>
              </a:ext>
            </a:extLst>
          </p:cNvPr>
          <p:cNvSpPr txBox="1"/>
          <p:nvPr/>
        </p:nvSpPr>
        <p:spPr>
          <a:xfrm>
            <a:off x="387502" y="302718"/>
            <a:ext cx="1872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g(II)PpIX, E795A</a:t>
            </a:r>
            <a:endParaRPr lang="de-DE" baseline="30000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767470A0-B134-2738-848B-66FEA94C7349}"/>
              </a:ext>
            </a:extLst>
          </p:cNvPr>
          <p:cNvSpPr txBox="1"/>
          <p:nvPr/>
        </p:nvSpPr>
        <p:spPr>
          <a:xfrm>
            <a:off x="2252325" y="4669671"/>
            <a:ext cx="7697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/>
              <a:t>09513</a:t>
            </a:r>
            <a:br>
              <a:rPr lang="de-DE" dirty="0"/>
            </a:br>
            <a:r>
              <a:rPr lang="de-DE" dirty="0"/>
              <a:t>47 </a:t>
            </a:r>
            <a:r>
              <a:rPr lang="de-DE" dirty="0" err="1"/>
              <a:t>ns</a:t>
            </a:r>
            <a:endParaRPr lang="de-DE" dirty="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2FC4EE42-8419-4ADC-983F-B32F33B44B0D}"/>
              </a:ext>
            </a:extLst>
          </p:cNvPr>
          <p:cNvSpPr txBox="1"/>
          <p:nvPr/>
        </p:nvSpPr>
        <p:spPr>
          <a:xfrm>
            <a:off x="5744370" y="4669671"/>
            <a:ext cx="7697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/>
              <a:t>22000</a:t>
            </a:r>
          </a:p>
          <a:p>
            <a:pPr algn="ctr"/>
            <a:r>
              <a:rPr lang="de-DE" dirty="0"/>
              <a:t>31 </a:t>
            </a:r>
            <a:r>
              <a:rPr lang="de-DE" dirty="0" err="1"/>
              <a:t>ns</a:t>
            </a:r>
            <a:endParaRPr lang="de-DE" dirty="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446AA7F1-3C46-75EB-74E0-B43466770200}"/>
              </a:ext>
            </a:extLst>
          </p:cNvPr>
          <p:cNvSpPr txBox="1"/>
          <p:nvPr/>
        </p:nvSpPr>
        <p:spPr>
          <a:xfrm>
            <a:off x="9319541" y="4669671"/>
            <a:ext cx="7697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/>
              <a:t>56882</a:t>
            </a:r>
          </a:p>
          <a:p>
            <a:pPr algn="ctr"/>
            <a:r>
              <a:rPr lang="de-DE" dirty="0"/>
              <a:t>34 </a:t>
            </a:r>
            <a:r>
              <a:rPr lang="de-DE" dirty="0" err="1"/>
              <a:t>ns</a:t>
            </a:r>
            <a:endParaRPr lang="de-DE" dirty="0"/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6913E639-716D-3A44-0631-5BB7441BD5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40000"/>
            <a:ext cx="5422900" cy="3048000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6A4B08B2-9030-F36A-AB28-77BFFC00126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69100" y="1440000"/>
            <a:ext cx="5422900" cy="3048000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DE997289-EB3A-AB4E-E5E9-91EAAFD603A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6991" r="20620"/>
          <a:stretch/>
        </p:blipFill>
        <p:spPr>
          <a:xfrm>
            <a:off x="4305993" y="1440000"/>
            <a:ext cx="338328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4247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Macintosh PowerPoint</Application>
  <PresentationFormat>Breitbild</PresentationFormat>
  <Paragraphs>27</Paragraphs>
  <Slides>5</Slides>
  <Notes>5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efan Heinemann</dc:creator>
  <cp:lastModifiedBy>Stefan Heinemann</cp:lastModifiedBy>
  <cp:revision>15</cp:revision>
  <dcterms:created xsi:type="dcterms:W3CDTF">2025-02-27T12:38:56Z</dcterms:created>
  <dcterms:modified xsi:type="dcterms:W3CDTF">2025-08-04T10:02:01Z</dcterms:modified>
</cp:coreProperties>
</file>